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95166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CD32B-3817-4139-9A32-C06BAAEF00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3D874-B50D-4C7A-8AC4-66DAC1AD5F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CF2DA-8BED-4E93-AD51-3DF2172769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349F7-EC36-4750-BC15-E151A887DA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C2C7F-0341-4774-8B4D-3EA4CFCB89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0EC37-06BE-4E91-A87F-A055F03ED9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CE558-A835-45C5-9C84-EE7B17879A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7188E-C71F-45B5-913D-D2C455FD78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A6EF5-0081-42F3-A4C8-28CF6269B3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8C693-D1D4-44ED-A711-942262EEBD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B869C-8BE8-4F56-B21C-83EF79C3B0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8D238-71B7-49CF-9E57-2DE4DD82E5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31080E-3B27-4D20-B841-29EE170544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35200" y="2568600"/>
            <a:ext cx="74847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. Volcano plots for gene expression comparisons considered in this study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(2) transformed fold changes (X-axes) are plotted against negative log10 transformed Benjamini and Hochberg corrected Student’s two-tailed t-test (Y-axes)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values for all 22,283 probe tilings in a given comparison. Data is provided for the following comparisons: (A) 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 cultures versus A549 cell cultures, (B) 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xenografts versus A549 xenografts, (C) A549 xenografts versus A549 cell cultures, and (D) 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xenografts versus A549 cell cultures. All cell culture experiments were conducted in triplicate while all xenograft experiments were conducted in quadruplicat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rcRect l="3551" t="5560" r="13715" b="15572"/>
          <a:stretch/>
        </p:blipFill>
        <p:spPr>
          <a:xfrm>
            <a:off x="706320" y="281160"/>
            <a:ext cx="3656160" cy="228600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4695480" y="5977080"/>
            <a:ext cx="3943440" cy="261360"/>
            <a:chOff x="4695480" y="5977080"/>
            <a:chExt cx="3943440" cy="261360"/>
          </a:xfrm>
        </p:grpSpPr>
        <p:sp>
          <p:nvSpPr>
            <p:cNvPr id="44" name=""/>
            <p:cNvSpPr/>
            <p:nvPr/>
          </p:nvSpPr>
          <p:spPr>
            <a:xfrm>
              <a:off x="657252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01856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48512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93692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838044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06852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60988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15916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69548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3" name="" descr=""/>
          <p:cNvPicPr/>
          <p:nvPr/>
        </p:nvPicPr>
        <p:blipFill>
          <a:blip r:embed="rId2"/>
          <a:srcRect l="3516" t="5560" r="14219" b="15937"/>
          <a:stretch/>
        </p:blipFill>
        <p:spPr>
          <a:xfrm>
            <a:off x="4849920" y="281160"/>
            <a:ext cx="3655800" cy="228600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1391400" y="3097080"/>
            <a:ext cx="226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vitro versus A549 vitr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627520" y="3097080"/>
            <a:ext cx="22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vivo versus A549 viv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3"/>
          <a:srcRect l="3557" t="5560" r="13738" b="16316"/>
          <a:stretch/>
        </p:blipFill>
        <p:spPr>
          <a:xfrm>
            <a:off x="706320" y="3679920"/>
            <a:ext cx="3656160" cy="228600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1432800" y="6450120"/>
            <a:ext cx="207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 vivo versus A549 vitr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4"/>
          <a:srcRect l="3516" t="5560" r="14056" b="16316"/>
          <a:stretch/>
        </p:blipFill>
        <p:spPr>
          <a:xfrm>
            <a:off x="4849920" y="3679920"/>
            <a:ext cx="3655800" cy="228600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5477040" y="6450120"/>
            <a:ext cx="242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vivo versus A549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vitr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4695480" y="2624040"/>
            <a:ext cx="3943440" cy="261360"/>
            <a:chOff x="4695480" y="2624040"/>
            <a:chExt cx="3943440" cy="261360"/>
          </a:xfrm>
        </p:grpSpPr>
        <p:sp>
          <p:nvSpPr>
            <p:cNvPr id="61" name=""/>
            <p:cNvSpPr/>
            <p:nvPr/>
          </p:nvSpPr>
          <p:spPr>
            <a:xfrm>
              <a:off x="657252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01856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48512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93692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838044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06852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60988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15916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69548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"/>
          <p:cNvGrpSpPr/>
          <p:nvPr/>
        </p:nvGrpSpPr>
        <p:grpSpPr>
          <a:xfrm>
            <a:off x="536040" y="5977080"/>
            <a:ext cx="3943440" cy="261360"/>
            <a:chOff x="536040" y="5977080"/>
            <a:chExt cx="3943440" cy="261360"/>
          </a:xfrm>
        </p:grpSpPr>
        <p:sp>
          <p:nvSpPr>
            <p:cNvPr id="71" name=""/>
            <p:cNvSpPr/>
            <p:nvPr/>
          </p:nvSpPr>
          <p:spPr>
            <a:xfrm>
              <a:off x="241308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5912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32568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77748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221000" y="5977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90908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45044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99972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36040" y="597708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"/>
          <p:cNvGrpSpPr/>
          <p:nvPr/>
        </p:nvGrpSpPr>
        <p:grpSpPr>
          <a:xfrm>
            <a:off x="536040" y="2624040"/>
            <a:ext cx="3943440" cy="261360"/>
            <a:chOff x="536040" y="2624040"/>
            <a:chExt cx="3943440" cy="261360"/>
          </a:xfrm>
        </p:grpSpPr>
        <p:sp>
          <p:nvSpPr>
            <p:cNvPr id="81" name=""/>
            <p:cNvSpPr/>
            <p:nvPr/>
          </p:nvSpPr>
          <p:spPr>
            <a:xfrm>
              <a:off x="241308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85912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32568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77748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221000" y="2624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90908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45044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99972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36040" y="2624040"/>
              <a:ext cx="30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"/>
          <p:cNvGrpSpPr/>
          <p:nvPr/>
        </p:nvGrpSpPr>
        <p:grpSpPr>
          <a:xfrm>
            <a:off x="450720" y="3554280"/>
            <a:ext cx="262080" cy="2503080"/>
            <a:chOff x="450720" y="3554280"/>
            <a:chExt cx="262080" cy="2503080"/>
          </a:xfrm>
        </p:grpSpPr>
        <p:sp>
          <p:nvSpPr>
            <p:cNvPr id="91" name=""/>
            <p:cNvSpPr/>
            <p:nvPr/>
          </p:nvSpPr>
          <p:spPr>
            <a:xfrm>
              <a:off x="450720" y="35542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50720" y="57960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50720" y="41241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50720" y="46814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50720" y="52354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H="1">
              <a:off x="666720" y="536256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666720" y="481644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H="1">
              <a:off x="666720" y="425448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H="1">
              <a:off x="666720" y="368928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H="1">
              <a:off x="666720" y="592452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" name=""/>
          <p:cNvGrpSpPr/>
          <p:nvPr/>
        </p:nvGrpSpPr>
        <p:grpSpPr>
          <a:xfrm>
            <a:off x="4597200" y="3554280"/>
            <a:ext cx="262080" cy="2503080"/>
            <a:chOff x="4597200" y="3554280"/>
            <a:chExt cx="262080" cy="2503080"/>
          </a:xfrm>
        </p:grpSpPr>
        <p:sp>
          <p:nvSpPr>
            <p:cNvPr id="102" name=""/>
            <p:cNvSpPr/>
            <p:nvPr/>
          </p:nvSpPr>
          <p:spPr>
            <a:xfrm>
              <a:off x="4597200" y="35542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597200" y="57960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597200" y="41241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597200" y="46814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597200" y="52354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H="1">
              <a:off x="4813200" y="536256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H="1">
              <a:off x="4813200" y="481644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H="1">
              <a:off x="4813200" y="425448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H="1">
              <a:off x="4813200" y="368928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H="1">
              <a:off x="4813200" y="5924520"/>
              <a:ext cx="460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"/>
          <p:cNvGrpSpPr/>
          <p:nvPr/>
        </p:nvGrpSpPr>
        <p:grpSpPr>
          <a:xfrm>
            <a:off x="4602240" y="160200"/>
            <a:ext cx="263520" cy="2485800"/>
            <a:chOff x="4602240" y="160200"/>
            <a:chExt cx="263520" cy="2485800"/>
          </a:xfrm>
        </p:grpSpPr>
        <p:sp>
          <p:nvSpPr>
            <p:cNvPr id="113" name=""/>
            <p:cNvSpPr/>
            <p:nvPr/>
          </p:nvSpPr>
          <p:spPr>
            <a:xfrm>
              <a:off x="4602240" y="160200"/>
              <a:ext cx="261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603680" y="23846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603680" y="7254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603680" y="12787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603680" y="18284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H="1">
              <a:off x="4819680" y="1954440"/>
              <a:ext cx="4608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H="1">
              <a:off x="4819680" y="1412640"/>
              <a:ext cx="4608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H="1">
              <a:off x="4819680" y="855000"/>
              <a:ext cx="4608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H="1">
              <a:off x="4819680" y="294120"/>
              <a:ext cx="4608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H="1">
              <a:off x="4819680" y="2512080"/>
              <a:ext cx="4608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"/>
          <p:cNvSpPr/>
          <p:nvPr/>
        </p:nvSpPr>
        <p:spPr>
          <a:xfrm>
            <a:off x="449280" y="179280"/>
            <a:ext cx="262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51080" y="237492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51080" y="7286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51080" y="12794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51080" y="182556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H="1">
            <a:off x="666720" y="1949400"/>
            <a:ext cx="46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H="1">
            <a:off x="666720" y="1411200"/>
            <a:ext cx="46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H="1">
            <a:off x="666720" y="857160"/>
            <a:ext cx="46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H="1">
            <a:off x="666720" y="311040"/>
            <a:ext cx="46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H="1">
            <a:off x="666720" y="2502000"/>
            <a:ext cx="460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6200000">
            <a:off x="-481680" y="1177920"/>
            <a:ext cx="17323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B-H correct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6200000">
            <a:off x="-472320" y="4587840"/>
            <a:ext cx="17323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B-H correct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821240" y="2871720"/>
            <a:ext cx="1413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ld 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040800" y="2852640"/>
            <a:ext cx="1413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ld 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764360" y="6224760"/>
            <a:ext cx="1413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ld 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5983920" y="6224760"/>
            <a:ext cx="1413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ld 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690840" y="277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4805640" y="277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690840" y="36590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805640" y="36590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-57600" y="6657840"/>
            <a:ext cx="1665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gda et al. Additional File 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2T08:10:39Z</dcterms:created>
  <dc:creator>Joseph G. Hacia</dc:creator>
  <dc:description/>
  <dc:language>en-US</dc:language>
  <cp:lastModifiedBy>Joseph G. Hacia</cp:lastModifiedBy>
  <dcterms:modified xsi:type="dcterms:W3CDTF">2008-10-30T00:30:30Z</dcterms:modified>
  <cp:revision>32</cp:revision>
  <dc:subject/>
  <dc:title>Slide 1</dc:title>
</cp:coreProperties>
</file>